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5">
  <p:sldMasterIdLst>
    <p:sldMasterId id="2147483648" r:id="rId4"/>
  </p:sldMasterIdLst>
  <p:notesMasterIdLst>
    <p:notesMasterId r:id="rId6"/>
  </p:notesMasterIdLst>
  <p:sldIdLst>
    <p:sldId id="29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A31C418-18D7-FC01-4DB0-DB8C5F15C850}" name="Aziana Abu Hassan" initials="AAH" userId="Aziana Abu Hassan" providerId="None"/>
  <p188:author id="{307D5664-BCA0-BEA9-4FF5-496CF704CFAE}" name="Marko Hanzevacki (staff)" initials="MH(" userId="Marko Hanzevacki (staff)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E1EFA"/>
    <a:srgbClr val="FFA000"/>
    <a:srgbClr val="02FF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65" autoAdjust="0"/>
    <p:restoredTop sz="85830" autoAdjust="0"/>
  </p:normalViewPr>
  <p:slideViewPr>
    <p:cSldViewPr snapToGrid="0">
      <p:cViewPr varScale="1">
        <p:scale>
          <a:sx n="96" d="100"/>
          <a:sy n="96" d="100"/>
        </p:scale>
        <p:origin x="11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ca Pordea (staff)" userId="04217c9e-4602-4538-8d25-5638668eb9f5" providerId="ADAL" clId="{94631504-17B6-479E-A37E-454F09B00C36}"/>
    <pc:docChg chg="delSld modSld">
      <pc:chgData name="Anca Pordea (staff)" userId="04217c9e-4602-4538-8d25-5638668eb9f5" providerId="ADAL" clId="{94631504-17B6-479E-A37E-454F09B00C36}" dt="2023-12-19T19:13:26.128" v="9" actId="1076"/>
      <pc:docMkLst>
        <pc:docMk/>
      </pc:docMkLst>
      <pc:sldChg chg="addSp modSp mod">
        <pc:chgData name="Anca Pordea (staff)" userId="04217c9e-4602-4538-8d25-5638668eb9f5" providerId="ADAL" clId="{94631504-17B6-479E-A37E-454F09B00C36}" dt="2023-12-19T19:13:26.128" v="9" actId="1076"/>
        <pc:sldMkLst>
          <pc:docMk/>
          <pc:sldMk cId="3804230355" sldId="293"/>
        </pc:sldMkLst>
        <pc:spChg chg="add mod">
          <ac:chgData name="Anca Pordea (staff)" userId="04217c9e-4602-4538-8d25-5638668eb9f5" providerId="ADAL" clId="{94631504-17B6-479E-A37E-454F09B00C36}" dt="2023-12-19T19:13:26.128" v="9" actId="1076"/>
          <ac:spMkLst>
            <pc:docMk/>
            <pc:sldMk cId="3804230355" sldId="293"/>
            <ac:spMk id="4" creationId="{CDF9A930-2382-62BA-C17A-E3BD13153A10}"/>
          </ac:spMkLst>
        </pc:spChg>
      </pc:sldChg>
      <pc:sldChg chg="del">
        <pc:chgData name="Anca Pordea (staff)" userId="04217c9e-4602-4538-8d25-5638668eb9f5" providerId="ADAL" clId="{94631504-17B6-479E-A37E-454F09B00C36}" dt="2023-12-18T19:08:46.199" v="0" actId="47"/>
        <pc:sldMkLst>
          <pc:docMk/>
          <pc:sldMk cId="3892218898" sldId="31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86DAC8-0F5C-40C4-9048-03E5F0338584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2B562-5671-4D39-9920-23E3852B6F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8403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spcBef>
                <a:spcPts val="200"/>
              </a:spcBef>
            </a:pPr>
            <a:r>
              <a:rPr lang="en-GB" sz="18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S3 Table. Impact of the size of the defined protein binding site on the </a:t>
            </a:r>
            <a:r>
              <a:rPr lang="en-GB" sz="1800" b="1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ChemPLP</a:t>
            </a:r>
            <a:r>
              <a:rPr lang="en-GB" sz="18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 docking scores</a:t>
            </a:r>
            <a:r>
              <a:rPr lang="en-GB" sz="1800" b="0" dirty="0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. Docking solutions are obtained from flexible docking using the </a:t>
            </a:r>
            <a:r>
              <a:rPr lang="en-GB" sz="1800" b="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ChemPLP</a:t>
            </a:r>
            <a:r>
              <a:rPr lang="en-GB" sz="1800" b="0" dirty="0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 scoring function within the GOLD software. The docking was performed in a binding site defined as all atoms within 10 or 15 Å from the central iron atom in </a:t>
            </a:r>
            <a:r>
              <a:rPr lang="en-GB" sz="1800" b="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heme</a:t>
            </a:r>
            <a:r>
              <a:rPr lang="en-GB" sz="1800" b="0" dirty="0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. The 10 docking solutions are ranked based on the fitness score from highest to lowest.</a:t>
            </a:r>
            <a:endParaRPr lang="en-GB" sz="1800" b="1" dirty="0">
              <a:effectLst/>
              <a:latin typeface="Calibri" panose="020F0502020204030204" pitchFamily="34" charset="0"/>
              <a:ea typeface="Yu Gothic Light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82B562-5671-4D39-9920-23E3852B6FD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022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839CC-2F4F-9676-481C-A8C6BD60D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B78B30-6C9E-9383-5A22-347469CEE2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F3B91-4E34-CF19-361A-C8592EC86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C2D85-0EFD-F1E1-E255-D409A42D7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04A4AE-7753-7C00-721D-98EB26BA0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339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454C2-05D2-40B2-C98F-42188163E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A9FF01-EC14-452C-3CE0-F69E790709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E166A-724F-0654-6132-EB6D136E6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5865FF-D369-A9FB-BE86-F396D4D2E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AD3664-4433-2CAF-0724-6D43A5EDC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9828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E88ECF-540D-9D8B-AA3D-0BFBCF95FB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DF5B47-A83B-3433-E305-0968F562A8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4D5D9-63A2-6610-C517-62DD48C0F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B9AA1-97FE-DF9C-A3CB-5C208B826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75377F-1DCC-3F4C-1493-4EB469A4B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91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743F2-CAC8-CCE5-22CC-8CCBCD2DF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F9F779-89A1-544A-951D-A892F041EA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9A8DE-F0E3-F7D3-F0D4-FF0540892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D0439-C25F-AD3D-FB4B-F9C044F03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2FB56-DEEF-B1EC-BB2B-6B06B28E5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6120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D81C7-B648-ECBB-EB5A-190AA8780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B8D037-CFF8-3CAE-B59F-42FF4DE911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3928D-3201-D840-2A36-11982338F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EDBB0-1CBA-B1A9-36C6-CD364295E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EA93A-115B-D044-5063-CCA7ACB1C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7324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D1655-2CC5-8A36-679E-B66A3C818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E9BB75-23E1-8048-21F0-8291ADA465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1A3F4A-1C5D-7B02-8B21-9555A35726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4E35E8-F04A-5333-D410-00E243298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A075AA-CC28-DF86-0F94-4D99C3AC9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BFF910-1687-8D7A-1E60-FB4E3700E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942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6B51B-A49C-DB81-129D-770B7B81E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D9DB3-E956-030A-1DF5-3FB9D03B44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D2E3A9-FCD4-5AFE-85C4-F8F4DDA71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A0BCEB-5EF9-7EE9-599C-6B94A4674A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392368-689C-6BF0-C77F-0FC8D9730B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521DC13-1D6B-88D7-E33B-841299F68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1249E9-F2D9-4CE8-E6E4-69784C915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DCCF0F-0559-9B9A-9D3B-F937169A2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448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E970B-DA53-0A74-ECA7-73762CEB3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14DDAA-CD12-6445-0D2D-6426A9B8D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4ED273-A5E0-4AA0-9FB8-376853020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24533B-EB08-5EF6-12E6-A61B91BB1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049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CCA8A7-6C30-3E41-FDA4-305B64DA9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98FDF7-8B82-C3B9-B1D3-F8A0D4019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B7E57B-3FA1-1E79-D470-B0A644558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219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032A7-73AA-3738-F12D-A9F0F15F7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9093D-A355-AE1D-2978-2A67002740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DE4AE4-E591-8AD3-0D49-79DAC0AD2F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C028F-B9A0-811D-83B5-8780FC264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1EC2C9-44C6-5DDA-05D2-3CBF197BF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4A6038-8120-45EA-B5FE-EDC53B703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9556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EFBDF-8326-737F-3DE1-8A0F176EF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5A8341-5D99-22B5-5588-0F213643C6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1F0F35-0A56-8640-3CB0-13C12B476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94D0A3-D271-0D2E-F074-B7ACC0632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72C26D-735A-EDE8-811B-C6F37C007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1E86F7-F0E0-0A6F-02B3-303AB6C43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666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F7FA97-498A-322A-7FC1-14CEFA006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C761D6-4CC6-BD9F-31FF-4C66405D9E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92A81E-83E9-C733-B6FA-CCC1763CC7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D18AAE-C4F2-C908-CFD8-36D483C0CB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562CB5-FAC8-96AE-9FC4-FD1DF197A0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404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0CE338C-EE88-F9B7-8327-3EAB9D54CF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8912401"/>
              </p:ext>
            </p:extLst>
          </p:nvPr>
        </p:nvGraphicFramePr>
        <p:xfrm>
          <a:off x="3294158" y="2244856"/>
          <a:ext cx="4677410" cy="1874081"/>
        </p:xfrm>
        <a:graphic>
          <a:graphicData uri="http://schemas.openxmlformats.org/drawingml/2006/table">
            <a:tbl>
              <a:tblPr firstRow="1" firstCol="1" bandRow="1"/>
              <a:tblGrid>
                <a:gridCol w="1558925">
                  <a:extLst>
                    <a:ext uri="{9D8B030D-6E8A-4147-A177-3AD203B41FA5}">
                      <a16:colId xmlns:a16="http://schemas.microsoft.com/office/drawing/2014/main" val="1934314250"/>
                    </a:ext>
                  </a:extLst>
                </a:gridCol>
                <a:gridCol w="1558925">
                  <a:extLst>
                    <a:ext uri="{9D8B030D-6E8A-4147-A177-3AD203B41FA5}">
                      <a16:colId xmlns:a16="http://schemas.microsoft.com/office/drawing/2014/main" val="1035312656"/>
                    </a:ext>
                  </a:extLst>
                </a:gridCol>
                <a:gridCol w="1559560">
                  <a:extLst>
                    <a:ext uri="{9D8B030D-6E8A-4147-A177-3AD203B41FA5}">
                      <a16:colId xmlns:a16="http://schemas.microsoft.com/office/drawing/2014/main" val="278113146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ank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 Å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5 Å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52234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8.9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9.3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83416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7.2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5.5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78038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4.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3.59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76458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.51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0.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83404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9.7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9.1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898997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1.3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.44</a:t>
                      </a:r>
                      <a:endParaRPr lang="en-MY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43689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0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3.17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91832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3.14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8.69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81178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42.16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.23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06369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60.12</a:t>
                      </a:r>
                      <a:endParaRPr lang="en-MY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1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8.18</a:t>
                      </a:r>
                      <a:endParaRPr lang="en-MY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521304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DF9A930-2382-62BA-C17A-E3BD13153A10}"/>
              </a:ext>
            </a:extLst>
          </p:cNvPr>
          <p:cNvSpPr txBox="1"/>
          <p:nvPr/>
        </p:nvSpPr>
        <p:spPr>
          <a:xfrm>
            <a:off x="3197707" y="1031150"/>
            <a:ext cx="487031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S3 Table. Impact of the size of the defined protein binding site on the </a:t>
            </a:r>
            <a:r>
              <a:rPr lang="en-GB" sz="1100" b="1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ChemPLP</a:t>
            </a:r>
            <a:r>
              <a:rPr lang="en-GB" sz="11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 docking scores</a:t>
            </a:r>
            <a:r>
              <a:rPr lang="en-GB" sz="1100" b="0" dirty="0">
                <a:effectLst/>
                <a:latin typeface="Arial" panose="020B0604020202020204" pitchFamily="34" charset="0"/>
                <a:ea typeface="Yu Gothic Light" panose="020B0300000000000000" pitchFamily="34" charset="-128"/>
                <a:cs typeface="Times New Roman" panose="02020603050405020304" pitchFamily="18" charset="0"/>
              </a:rPr>
              <a:t>. </a:t>
            </a:r>
            <a:r>
              <a:rPr lang="en-GB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ocking solutions are obtained from flexible docking using the </a:t>
            </a:r>
            <a:r>
              <a:rPr lang="en-GB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hemPLP</a:t>
            </a:r>
            <a:r>
              <a:rPr lang="en-GB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scoring function within the GOLD software. The docking was performed in a binding site defined as all atoms within 10 or 15 Å from the central iron atom in </a:t>
            </a:r>
            <a:r>
              <a:rPr lang="en-GB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heme</a:t>
            </a:r>
            <a:r>
              <a:rPr lang="en-GB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The 10 docking solutions are ranked based on the fitness score from highest to lowest.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38042303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c1e910d-4918-42f1-af2c-ed1101d63abc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7573F99DE79145B2C4B20841E12603" ma:contentTypeVersion="17" ma:contentTypeDescription="Create a new document." ma:contentTypeScope="" ma:versionID="75a924c6fce2bfbfdafe8aa5030a8127">
  <xsd:schema xmlns:xsd="http://www.w3.org/2001/XMLSchema" xmlns:xs="http://www.w3.org/2001/XMLSchema" xmlns:p="http://schemas.microsoft.com/office/2006/metadata/properties" xmlns:ns3="0c1e910d-4918-42f1-af2c-ed1101d63abc" xmlns:ns4="786e620f-b1da-4f59-878c-ef7546d25bf1" targetNamespace="http://schemas.microsoft.com/office/2006/metadata/properties" ma:root="true" ma:fieldsID="84345ca33903240b6bb317a7195b494d" ns3:_="" ns4:_="">
    <xsd:import namespace="0c1e910d-4918-42f1-af2c-ed1101d63abc"/>
    <xsd:import namespace="786e620f-b1da-4f59-878c-ef7546d25bf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c1e910d-4918-42f1-af2c-ed1101d63ab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6e620f-b1da-4f59-878c-ef7546d25bf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9FF0F8F7-5F66-4883-BEC4-F64859C3F4BC}">
  <ds:schemaRefs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elements/1.1/"/>
    <ds:schemaRef ds:uri="http://purl.org/dc/terms/"/>
    <ds:schemaRef ds:uri="0c1e910d-4918-42f1-af2c-ed1101d63abc"/>
    <ds:schemaRef ds:uri="http://schemas.microsoft.com/office/infopath/2007/PartnerControls"/>
    <ds:schemaRef ds:uri="786e620f-b1da-4f59-878c-ef7546d25bf1"/>
    <ds:schemaRef ds:uri="http://schemas.microsoft.com/office/2006/documentManagement/type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F56DA7E7-3482-4CEA-AA13-D1276F6BD35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c1e910d-4918-42f1-af2c-ed1101d63abc"/>
    <ds:schemaRef ds:uri="786e620f-b1da-4f59-878c-ef7546d25bf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8BC3993-CD11-46D5-AFD3-539F9D1D026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414</TotalTime>
  <Words>193</Words>
  <Application>Microsoft Office PowerPoint</Application>
  <PresentationFormat>Widescreen</PresentationFormat>
  <Paragraphs>3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o Hanzevacki (staff)</dc:creator>
  <cp:lastModifiedBy>Anca Pordea (staff)</cp:lastModifiedBy>
  <cp:revision>366</cp:revision>
  <dcterms:created xsi:type="dcterms:W3CDTF">2022-09-23T18:06:25Z</dcterms:created>
  <dcterms:modified xsi:type="dcterms:W3CDTF">2023-12-19T19:13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7573F99DE79145B2C4B20841E12603</vt:lpwstr>
  </property>
</Properties>
</file>